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42D78-F327-4097-AF09-B6885AD95D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717CE-E771-451B-B987-C18216FA59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8278C-25FE-448A-886E-BE4D5B13DE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8EBA6-32AF-4DD5-9E9B-A0AFE88BE0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99826-C36B-4B08-A1BC-FD7CAD2BFC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EB12E-1D7E-4963-9A1C-CF00AC31E2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64A84-0413-4854-8ECF-D43341C400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B3E1B-4215-403A-8FD8-BC9808846D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9794F-DAE9-46DE-8F35-635432A9A8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A71B3-4B59-45B2-AF94-4713B6032B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82D65-F88E-4BCF-B754-DED87DC28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6F112-4383-4BED-BE23-9CEBE70AE0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E92D06-6EC8-407D-9149-2B5A4C91EFD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3" descr="F:\Gyan Office-Laptop\DGR Publications\Tanmoy TC  New\Plos\Figure 9 S5.tif"/>
          <p:cNvPicPr/>
          <p:nvPr/>
        </p:nvPicPr>
        <p:blipFill>
          <a:blip r:embed="rId1"/>
          <a:stretch/>
        </p:blipFill>
        <p:spPr>
          <a:xfrm>
            <a:off x="380880" y="1066680"/>
            <a:ext cx="8077320" cy="312444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14"/>
          <p:cNvSpPr/>
          <p:nvPr/>
        </p:nvSpPr>
        <p:spPr>
          <a:xfrm>
            <a:off x="228600" y="4572000"/>
            <a:ext cx="8763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. Recovery of wild type (WT) and transgenic (T) lines in Hoagland’s solution. </a:t>
            </a:r>
            <a:r>
              <a:rPr b="0" lang="en-I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covery after 6 days following exposure to 20% PEG for 3 days (A) and recovery of WT and T in Hoagland’s solution after 6 days following exposure to 200 mM NaCl for 7 days (B)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4T18:09:22Z</dcterms:created>
  <dc:creator>Dr. Radhakrishnan</dc:creator>
  <dc:description/>
  <dc:language>en-US</dc:language>
  <cp:lastModifiedBy>Dr. Radhakrishnan</cp:lastModifiedBy>
  <dcterms:modified xsi:type="dcterms:W3CDTF">2014-11-24T18:18:11Z</dcterms:modified>
  <cp:revision>5</cp:revision>
  <dc:subject/>
  <dc:title>Slide 1</dc:title>
</cp:coreProperties>
</file>